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536" y="2573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B8D11-7487-4C60-AB5B-6BD2338065E6}" type="datetimeFigureOut">
              <a:rPr lang="en-US" smtClean="0"/>
              <a:t>9/1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44AF0-8107-461E-BE05-8E1D577D87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5841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B8D11-7487-4C60-AB5B-6BD2338065E6}" type="datetimeFigureOut">
              <a:rPr lang="en-US" smtClean="0"/>
              <a:t>9/1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44AF0-8107-461E-BE05-8E1D577D87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3583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B8D11-7487-4C60-AB5B-6BD2338065E6}" type="datetimeFigureOut">
              <a:rPr lang="en-US" smtClean="0"/>
              <a:t>9/1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44AF0-8107-461E-BE05-8E1D577D87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4741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B8D11-7487-4C60-AB5B-6BD2338065E6}" type="datetimeFigureOut">
              <a:rPr lang="en-US" smtClean="0"/>
              <a:t>9/1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44AF0-8107-461E-BE05-8E1D577D87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1107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B8D11-7487-4C60-AB5B-6BD2338065E6}" type="datetimeFigureOut">
              <a:rPr lang="en-US" smtClean="0"/>
              <a:t>9/1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44AF0-8107-461E-BE05-8E1D577D87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0498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B8D11-7487-4C60-AB5B-6BD2338065E6}" type="datetimeFigureOut">
              <a:rPr lang="en-US" smtClean="0"/>
              <a:t>9/1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44AF0-8107-461E-BE05-8E1D577D87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88430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B8D11-7487-4C60-AB5B-6BD2338065E6}" type="datetimeFigureOut">
              <a:rPr lang="en-US" smtClean="0"/>
              <a:t>9/11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44AF0-8107-461E-BE05-8E1D577D87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85502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B8D11-7487-4C60-AB5B-6BD2338065E6}" type="datetimeFigureOut">
              <a:rPr lang="en-US" smtClean="0"/>
              <a:t>9/11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44AF0-8107-461E-BE05-8E1D577D87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93020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B8D11-7487-4C60-AB5B-6BD2338065E6}" type="datetimeFigureOut">
              <a:rPr lang="en-US" smtClean="0"/>
              <a:t>9/11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44AF0-8107-461E-BE05-8E1D577D87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1675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B8D11-7487-4C60-AB5B-6BD2338065E6}" type="datetimeFigureOut">
              <a:rPr lang="en-US" smtClean="0"/>
              <a:t>9/1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44AF0-8107-461E-BE05-8E1D577D87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2142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B8D11-7487-4C60-AB5B-6BD2338065E6}" type="datetimeFigureOut">
              <a:rPr lang="en-US" smtClean="0"/>
              <a:t>9/1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44AF0-8107-461E-BE05-8E1D577D87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8591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8B8D11-7487-4C60-AB5B-6BD2338065E6}" type="datetimeFigureOut">
              <a:rPr lang="en-US" smtClean="0"/>
              <a:t>9/1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E44AF0-8107-461E-BE05-8E1D577D87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59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vodkinlab.UIUC\Desktop\File1320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41" t="3999" r="32602" b="66917"/>
          <a:stretch/>
        </p:blipFill>
        <p:spPr bwMode="auto">
          <a:xfrm>
            <a:off x="1737360" y="967740"/>
            <a:ext cx="3787726" cy="26593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5" name="Straight Connector 4"/>
          <p:cNvCxnSpPr/>
          <p:nvPr/>
        </p:nvCxnSpPr>
        <p:spPr>
          <a:xfrm>
            <a:off x="1905000" y="967740"/>
            <a:ext cx="33528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1752600" y="3609201"/>
            <a:ext cx="37914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ference position in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gene transcript sequence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588729" y="2119542"/>
            <a:ext cx="18675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o of RNA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read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194912" y="682823"/>
            <a:ext cx="26818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M38-</a:t>
            </a:r>
            <a:r>
              <a:rPr lang="en-US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00 mg RNA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read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1684020" y="4592181"/>
            <a:ext cx="3841066" cy="2750820"/>
            <a:chOff x="1684020" y="4107180"/>
            <a:chExt cx="3841066" cy="2750820"/>
          </a:xfrm>
        </p:grpSpPr>
        <p:pic>
          <p:nvPicPr>
            <p:cNvPr id="1027" name="Picture 3" descr="C:\Users\vodkinlab.UIUC\Desktop\File1320.JPG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93" t="39084" r="33148" b="30833"/>
            <a:stretch/>
          </p:blipFill>
          <p:spPr bwMode="auto">
            <a:xfrm>
              <a:off x="1684020" y="4107180"/>
              <a:ext cx="3841066" cy="27508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7" name="Straight Connector 6"/>
            <p:cNvCxnSpPr/>
            <p:nvPr/>
          </p:nvCxnSpPr>
          <p:spPr>
            <a:xfrm>
              <a:off x="1905000" y="4114800"/>
              <a:ext cx="33528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" name="TextBox 15"/>
          <p:cNvSpPr txBox="1"/>
          <p:nvPr/>
        </p:nvSpPr>
        <p:spPr>
          <a:xfrm rot="16200000">
            <a:off x="588730" y="5753881"/>
            <a:ext cx="18675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o of RNA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read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771177" y="7343001"/>
            <a:ext cx="41072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ference position in mutant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gene transcript sequence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194912" y="4267200"/>
            <a:ext cx="26818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M38-</a:t>
            </a:r>
            <a:r>
              <a:rPr lang="en-US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00 mg RNA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read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838200" y="6858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838200" y="427886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Down Arrow 20"/>
          <p:cNvSpPr/>
          <p:nvPr/>
        </p:nvSpPr>
        <p:spPr>
          <a:xfrm>
            <a:off x="2720340" y="2526792"/>
            <a:ext cx="76200" cy="673608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Down Arrow 25"/>
          <p:cNvSpPr/>
          <p:nvPr/>
        </p:nvSpPr>
        <p:spPr>
          <a:xfrm>
            <a:off x="2781300" y="5117592"/>
            <a:ext cx="76200" cy="673608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/>
          <p:cNvSpPr txBox="1"/>
          <p:nvPr/>
        </p:nvSpPr>
        <p:spPr>
          <a:xfrm>
            <a:off x="838200" y="7924800"/>
            <a:ext cx="533399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RNA sequence reads expressed in seed coats of 400 mg seed in the RM38 line with the defective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allele when aligned to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wild type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gene transcript sequence and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mutant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allele  transcript lacking the “C”-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t position 222. 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032295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92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Illinoi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niversity of Illinois</dc:creator>
  <cp:lastModifiedBy>University of Illinois</cp:lastModifiedBy>
  <cp:revision>5</cp:revision>
  <cp:lastPrinted>2014-09-11T22:27:48Z</cp:lastPrinted>
  <dcterms:created xsi:type="dcterms:W3CDTF">2014-09-11T21:35:05Z</dcterms:created>
  <dcterms:modified xsi:type="dcterms:W3CDTF">2014-09-11T22:28:59Z</dcterms:modified>
</cp:coreProperties>
</file>